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0287000" cy="6858000" type="35mm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2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28" y="-104"/>
      </p:cViewPr>
      <p:guideLst>
        <p:guide orient="horz" pos="2160"/>
        <p:guide pos="32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6"/>
            <a:ext cx="874395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2282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877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9"/>
            <a:ext cx="2314575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274639"/>
            <a:ext cx="6772275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2391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2397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1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9305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229225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7693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4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4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212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9077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6127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1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1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1" y="1435101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0575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1330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600201"/>
            <a:ext cx="92583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9C1329-6DE0-48CA-821F-B946447E2D5A}" type="datetimeFigureOut">
              <a:rPr kumimoji="1" lang="ja-JP" altLang="en-US" smtClean="0"/>
              <a:t>19/09/20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1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5844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tiff"/><Relationship Id="rId3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110" y="3979957"/>
            <a:ext cx="2376264" cy="26140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110" y="1091195"/>
            <a:ext cx="2376264" cy="25501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テキスト ボックス 7"/>
          <p:cNvSpPr txBox="1"/>
          <p:nvPr/>
        </p:nvSpPr>
        <p:spPr>
          <a:xfrm>
            <a:off x="946479" y="3563724"/>
            <a:ext cx="1877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10 sec exposur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11309" y="6516052"/>
            <a:ext cx="1877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0 sec exposur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1044950" y="2782549"/>
            <a:ext cx="1963455" cy="45093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/>
          <p:cNvSpPr/>
          <p:nvPr/>
        </p:nvSpPr>
        <p:spPr>
          <a:xfrm>
            <a:off x="1074573" y="4264640"/>
            <a:ext cx="1944326" cy="31315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964366" y="1307219"/>
            <a:ext cx="1459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Dia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1/DIA1</a:t>
            </a:r>
            <a:endParaRPr kumimoji="1" lang="en-US" altLang="ja-JP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33816" y="1576537"/>
            <a:ext cx="1092932" cy="28706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正方形/長方形 12"/>
          <p:cNvSpPr/>
          <p:nvPr/>
        </p:nvSpPr>
        <p:spPr>
          <a:xfrm>
            <a:off x="8649840" y="2370293"/>
            <a:ext cx="432048" cy="28803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8" name="正方形/長方形 17"/>
          <p:cNvSpPr/>
          <p:nvPr/>
        </p:nvSpPr>
        <p:spPr>
          <a:xfrm>
            <a:off x="8598753" y="3485583"/>
            <a:ext cx="432048" cy="28803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180030" y="2810095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kumimoji="1" lang="en-US" altLang="ja-JP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964366" y="4208460"/>
            <a:ext cx="1459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Dia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1/DIA1</a:t>
            </a:r>
            <a:endParaRPr kumimoji="1" lang="en-US" altLang="ja-JP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7591480" y="2333455"/>
            <a:ext cx="88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  <a:endParaRPr kumimoji="1" lang="en-US" altLang="ja-JP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498533" y="1846984"/>
            <a:ext cx="1459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Dia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1/DIA1</a:t>
            </a:r>
            <a:endParaRPr kumimoji="1" lang="en-US" altLang="ja-JP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835619" y="2780928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kumimoji="1" lang="en-US" altLang="ja-JP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9635292" y="3396297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37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9635292" y="313347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9635292" y="361581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2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9621694" y="3803592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2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9641198" y="2808049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7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9533734" y="262041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9542665" y="2368625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9533425" y="2143309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2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9599148" y="1556792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>
                <a:latin typeface="Arial" pitchFamily="34" charset="0"/>
                <a:cs typeface="Arial" pitchFamily="34" charset="0"/>
              </a:rPr>
              <a:t>kDa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9632258" y="3991162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1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-74015" y="-87925"/>
            <a:ext cx="44823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7C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238668" y="332848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37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256253" y="273154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254134" y="210717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7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62731" y="176127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62731" y="1334765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62731" y="101918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2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02524" y="673396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>
                <a:latin typeface="Arial" pitchFamily="34" charset="0"/>
                <a:cs typeface="Arial" pitchFamily="34" charset="0"/>
              </a:rPr>
              <a:t>kDa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50388" y="622468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37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267973" y="562774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265854" y="500337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7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174451" y="465747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174451" y="423096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174451" y="391538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2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6716615" y="3004018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37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6719210" y="272965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6717091" y="240191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7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6613640" y="219092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6610698" y="190659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6625688" y="157653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2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7279026" y="3448745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-GAPDH</a:t>
            </a:r>
            <a:endParaRPr kumimoji="1" lang="en-US" altLang="ja-JP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線コネクタ 2"/>
          <p:cNvCxnSpPr/>
          <p:nvPr/>
        </p:nvCxnSpPr>
        <p:spPr>
          <a:xfrm>
            <a:off x="5863580" y="4699758"/>
            <a:ext cx="381642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/>
          <p:cNvSpPr txBox="1"/>
          <p:nvPr/>
        </p:nvSpPr>
        <p:spPr>
          <a:xfrm>
            <a:off x="6864115" y="4861359"/>
            <a:ext cx="1672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HEK293 Cell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1094651" y="300822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ear</a:t>
            </a:r>
            <a:endParaRPr kumimoji="1" lang="ja-JP" altLang="en-US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1608686" y="335992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thymus</a:t>
            </a:r>
            <a:endParaRPr kumimoji="1" lang="ja-JP" altLang="en-US" sz="16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2410048" y="335992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kumimoji="1" lang="ja-JP" altLang="en-US" sz="16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 rot="16200000">
            <a:off x="1018596" y="697442"/>
            <a:ext cx="48282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 rot="16200000">
            <a:off x="1248607" y="688080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 rot="16200000">
            <a:off x="1716131" y="709162"/>
            <a:ext cx="48282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 rot="16200000">
            <a:off x="1946142" y="699800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 rot="16200000">
            <a:off x="2387158" y="685712"/>
            <a:ext cx="48282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 rot="16200000">
            <a:off x="2617169" y="693935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1015" y="1556792"/>
            <a:ext cx="754633" cy="28377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8" name="テキスト ボックス 67"/>
          <p:cNvSpPr txBox="1"/>
          <p:nvPr/>
        </p:nvSpPr>
        <p:spPr>
          <a:xfrm>
            <a:off x="6709744" y="3335652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2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6652726" y="1196752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>
                <a:latin typeface="Arial" pitchFamily="34" charset="0"/>
                <a:cs typeface="Arial" pitchFamily="34" charset="0"/>
              </a:rPr>
              <a:t>kDa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6106613" y="2808856"/>
            <a:ext cx="548660" cy="33068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/>
          <p:cNvSpPr/>
          <p:nvPr/>
        </p:nvSpPr>
        <p:spPr>
          <a:xfrm>
            <a:off x="6126288" y="1852275"/>
            <a:ext cx="548660" cy="40013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615075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-3675" y="0"/>
            <a:ext cx="44823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7B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628505" y="1412776"/>
            <a:ext cx="3370979" cy="2934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287516" y="1412776"/>
            <a:ext cx="3370979" cy="2934000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7087716" y="5939988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15 se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695228" y="5949280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10 m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1887945" y="989233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3104161" y="99631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2430731" y="99631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3726691" y="99631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8694698" y="1030023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>
                <a:latin typeface="Arial" pitchFamily="34" charset="0"/>
                <a:cs typeface="Arial" pitchFamily="34" charset="0"/>
              </a:rPr>
              <a:t>kDa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8790818" y="338904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7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662577" y="279730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8678568" y="206676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8678569" y="146688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2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 rot="16200000">
            <a:off x="5560353" y="977262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 rot="16200000">
            <a:off x="6791180" y="986593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 rot="16200000">
            <a:off x="6114111" y="99592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 rot="16200000">
            <a:off x="7316761" y="99592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線コネクタ 36"/>
          <p:cNvCxnSpPr/>
          <p:nvPr/>
        </p:nvCxnSpPr>
        <p:spPr>
          <a:xfrm>
            <a:off x="6867640" y="4412737"/>
            <a:ext cx="958818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/>
          <p:cNvCxnSpPr/>
          <p:nvPr/>
        </p:nvCxnSpPr>
        <p:spPr>
          <a:xfrm>
            <a:off x="5594210" y="4412737"/>
            <a:ext cx="958818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/>
          <p:cNvSpPr txBox="1"/>
          <p:nvPr/>
        </p:nvSpPr>
        <p:spPr>
          <a:xfrm>
            <a:off x="7001264" y="4393136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線コネクタ 41"/>
          <p:cNvCxnSpPr/>
          <p:nvPr/>
        </p:nvCxnSpPr>
        <p:spPr>
          <a:xfrm>
            <a:off x="3271292" y="4403445"/>
            <a:ext cx="958818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1975148" y="4403445"/>
            <a:ext cx="958818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/>
          <p:cNvSpPr txBox="1"/>
          <p:nvPr/>
        </p:nvSpPr>
        <p:spPr>
          <a:xfrm>
            <a:off x="3404916" y="4374513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928493" y="4383805"/>
            <a:ext cx="11079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Inner ear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正方形/長方形 45"/>
          <p:cNvSpPr/>
          <p:nvPr/>
        </p:nvSpPr>
        <p:spPr>
          <a:xfrm>
            <a:off x="6722228" y="1844824"/>
            <a:ext cx="1229584" cy="6480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正方形/長方形 46"/>
          <p:cNvSpPr/>
          <p:nvPr/>
        </p:nvSpPr>
        <p:spPr>
          <a:xfrm>
            <a:off x="1831132" y="1844824"/>
            <a:ext cx="1216533" cy="6480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0932" y="6021288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Exposure 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コネクタ 30"/>
          <p:cNvCxnSpPr/>
          <p:nvPr/>
        </p:nvCxnSpPr>
        <p:spPr>
          <a:xfrm>
            <a:off x="1576390" y="5127575"/>
            <a:ext cx="7095502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/>
          <p:cNvSpPr txBox="1"/>
          <p:nvPr/>
        </p:nvSpPr>
        <p:spPr>
          <a:xfrm>
            <a:off x="4582294" y="5271591"/>
            <a:ext cx="11817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kumimoji="1" lang="en-US" altLang="ja-JP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5524958" y="4386909"/>
            <a:ext cx="11079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Inner ear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07933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</TotalTime>
  <Words>113</Words>
  <Application>Microsoft Macintosh PowerPoint</Application>
  <PresentationFormat>35mm Slides</PresentationFormat>
  <Paragraphs>7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​​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 Ueyama</dc:creator>
  <cp:lastModifiedBy>Gerlinde Schuster</cp:lastModifiedBy>
  <cp:revision>23</cp:revision>
  <dcterms:created xsi:type="dcterms:W3CDTF">2016-03-26T09:28:40Z</dcterms:created>
  <dcterms:modified xsi:type="dcterms:W3CDTF">2016-09-19T12:52:23Z</dcterms:modified>
</cp:coreProperties>
</file>